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1971" r:id="rId2"/>
    <p:sldId id="1940" r:id="rId3"/>
    <p:sldId id="1966" r:id="rId4"/>
    <p:sldId id="1972" r:id="rId5"/>
    <p:sldId id="256" r:id="rId6"/>
    <p:sldId id="258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F7E79"/>
    <a:srgbClr val="FF8A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1150"/>
    <p:restoredTop sz="94665"/>
  </p:normalViewPr>
  <p:slideViewPr>
    <p:cSldViewPr snapToGrid="0">
      <p:cViewPr varScale="1">
        <p:scale>
          <a:sx n="98" d="100"/>
          <a:sy n="98" d="100"/>
        </p:scale>
        <p:origin x="224" y="3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549119-B5CC-7CC2-69EB-2CF083D84D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099B798-2220-F008-EF6D-F2BCD8DED8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1ABBDC-62B8-3C2B-9E4A-9A93378A1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4DEFBF8-0438-0D78-6CFB-FC22F72A32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98B381-2381-6185-ADBC-52F336BBC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5537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1D5C95-6B6D-6AAD-1843-20FFB2055E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C800ACE-1292-2E3E-66F7-BC7D9C6A1E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9E3984-E3EE-CA3C-ECCF-A619628486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D2242F-7493-9B13-1E55-BA79EE605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3BFB45-7762-8252-AF32-3009E17A4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067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EB1436D-43BD-45EB-597D-3C88A255AD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A703335-75E0-70D3-B1E4-B8F8588465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96203A-6E82-38F0-0188-912F4F870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6FEDD8-CC24-AF61-3202-FE74B3D16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8DF2EE-42C4-5F61-957D-DDF37438B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621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1B9AAD5-7323-8516-A5A5-164736F9EF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BC85716-0FEE-003F-D70A-60002DB52E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D13AC0-E435-0878-2637-A989410EA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6DDF20-02F7-F493-28B5-37EA752A5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DAE9FCC-53E7-259C-5999-9DA775F4B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0385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D805EC-28C6-F081-2F29-928E46C7DB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9FEC89-BC4F-25C9-A7D2-DB30FE488C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71A2BA-F2B7-1E9D-0CD1-8FB00EE3E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465F87-C78F-F59A-BDB1-0ACB2D95EE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637C08B-EF65-196D-8A5C-5051F221A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0141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173C19-5EC9-92B0-0CF9-9692AE9171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C3672F5-8793-8EE7-4756-CDFE5A680C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ED088FF-840A-4484-C864-A8C2ACB0AA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5B09AB0-0EBA-75AB-9D35-03FCC0349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3A48FD3-77D8-1364-8867-9C950E333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39626EB-EBF5-0130-6E35-FCC826A2F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9142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612996-D64D-AD6A-228C-5BA8D5CA3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8740430-F883-B426-5BF2-B481F0E4FB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EC57FB8-5544-4AFB-D316-18B073962B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7F13A51-3323-4EF0-90B8-5ADE8BDA3F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F4FF6B5-2EE4-F520-9FC8-C794A5A094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C62001D-5B16-A85D-6291-6A81EFCDB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8E157B2-0A1F-8F4E-CCFB-DF2BB3A55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F9847D4-2897-6458-80E0-40F810887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027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4C0452-BF01-7A24-0E0A-87DB7321BC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83D5423-0757-0CA4-390A-EDBD1E5F2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7A0DDB7-984C-A269-78C6-BEF927025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E7C65E2-522C-BED9-52C4-D9648A771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357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DB7533C-A50F-9F57-1E9D-5DF70D574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875FFD4-9B17-1197-796C-556D3AEA7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E4CF7EF-2297-D613-C47B-1456B9843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3208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9FB656-4FA7-57AE-C627-FC026EF2C9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BCF39CE-E0CA-A07A-7DAB-F5209BF1DF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0CD9A53-CCAC-233E-465D-9983046DAE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234AD9E-219E-4C8E-CF1F-541D8EF096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9BE2F23-8C71-6F7C-2DCC-EAAAF7571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186AD8-107E-02E5-7224-238D4478D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2449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37E483-1240-8DAF-BD0A-DA02F6CC5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525126B-FAEA-702A-E1CE-83B3C41007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8EF35E5-C15C-BC23-C7E7-5233225422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3B7B61F-87A0-B238-7957-1F64A26E3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91D3CAA-9BC4-C37B-3FB0-E22A4BB64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BF4249E-CC0D-E337-78BA-096AF66CE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119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906F09A-61CC-BB2C-0E1B-C30B850F3F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889C540-51A9-84EB-7027-4640C94394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18D61F-37FE-E047-CE39-79B016DC1C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2BD8F-4D28-6C40-8A59-B876BAA08542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3A3D4B-3218-7077-5705-9ED1DB2587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7EA1806-DD60-76F5-AC64-FC7B82DA60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0FAD53-2DA1-B64C-91A5-5B6E1D1910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7965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6D201C2-232C-2634-23AB-1443DE5F3F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0BD33DD4-5AC0-96AD-96A0-9EA329A5AF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5583901"/>
              </p:ext>
            </p:extLst>
          </p:nvPr>
        </p:nvGraphicFramePr>
        <p:xfrm>
          <a:off x="1750472" y="1034117"/>
          <a:ext cx="9212327" cy="5669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03630">
                  <a:extLst>
                    <a:ext uri="{9D8B030D-6E8A-4147-A177-3AD203B41FA5}">
                      <a16:colId xmlns:a16="http://schemas.microsoft.com/office/drawing/2014/main" val="865756447"/>
                    </a:ext>
                  </a:extLst>
                </a:gridCol>
                <a:gridCol w="2340928">
                  <a:extLst>
                    <a:ext uri="{9D8B030D-6E8A-4147-A177-3AD203B41FA5}">
                      <a16:colId xmlns:a16="http://schemas.microsoft.com/office/drawing/2014/main" val="3445915576"/>
                    </a:ext>
                  </a:extLst>
                </a:gridCol>
                <a:gridCol w="2532380">
                  <a:extLst>
                    <a:ext uri="{9D8B030D-6E8A-4147-A177-3AD203B41FA5}">
                      <a16:colId xmlns:a16="http://schemas.microsoft.com/office/drawing/2014/main" val="1983726366"/>
                    </a:ext>
                  </a:extLst>
                </a:gridCol>
                <a:gridCol w="2328609">
                  <a:extLst>
                    <a:ext uri="{9D8B030D-6E8A-4147-A177-3AD203B41FA5}">
                      <a16:colId xmlns:a16="http://schemas.microsoft.com/office/drawing/2014/main" val="3258249010"/>
                    </a:ext>
                  </a:extLst>
                </a:gridCol>
                <a:gridCol w="906780">
                  <a:extLst>
                    <a:ext uri="{9D8B030D-6E8A-4147-A177-3AD203B41FA5}">
                      <a16:colId xmlns:a16="http://schemas.microsoft.com/office/drawing/2014/main" val="2279036276"/>
                    </a:ext>
                  </a:extLst>
                </a:gridCol>
              </a:tblGrid>
              <a:tr h="229121">
                <a:tc gridSpan="2">
                  <a:txBody>
                    <a:bodyPr/>
                    <a:lstStyle/>
                    <a:p>
                      <a:endParaRPr kumimoji="1" lang="ja-JP" altLang="en-US" sz="1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1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DP regimen (n=91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1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CDDP regimen (n=56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1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p val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7657943"/>
                  </a:ext>
                </a:extLst>
              </a:tr>
              <a:tr h="229121">
                <a:tc gridSpan="2">
                  <a:txBody>
                    <a:bodyPr/>
                    <a:lstStyle/>
                    <a:p>
                      <a:r>
                        <a:rPr lang="en-US" altLang="ja-JP" sz="1800" b="1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Sex (Male : Female)</a:t>
                      </a:r>
                      <a:endParaRPr kumimoji="1" lang="ja-JP" altLang="en-US" sz="1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77 : 1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49 : 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535540"/>
                  </a:ext>
                </a:extLst>
              </a:tr>
              <a:tr h="229121">
                <a:tc gridSpan="2">
                  <a:txBody>
                    <a:bodyPr/>
                    <a:lstStyle/>
                    <a:p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Age (Median)</a:t>
                      </a:r>
                      <a:endParaRPr kumimoji="1" lang="ja-JP" altLang="en-US" sz="1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43-87 (69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1-87 (65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5092107"/>
                  </a:ext>
                </a:extLst>
              </a:tr>
              <a:tr h="229121">
                <a:tc gridSpan="2">
                  <a:txBody>
                    <a:bodyPr/>
                    <a:lstStyle/>
                    <a:p>
                      <a:r>
                        <a:rPr lang="en-US" altLang="ja-JP" sz="1800" b="1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Drinking behavior</a:t>
                      </a:r>
                      <a:endParaRPr kumimoji="1" lang="ja-JP" altLang="en-US" sz="1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63 (69%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9 (52%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6291855"/>
                  </a:ext>
                </a:extLst>
              </a:tr>
              <a:tr h="229121">
                <a:tc gridSpan="2">
                  <a:txBody>
                    <a:bodyPr/>
                    <a:lstStyle/>
                    <a:p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rrent smoker</a:t>
                      </a:r>
                      <a:endParaRPr kumimoji="1" lang="ja-JP" altLang="en-US" sz="1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 (82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 (71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6144627"/>
                  </a:ext>
                </a:extLst>
              </a:tr>
              <a:tr h="229121">
                <a:tc gridSpan="2">
                  <a:txBody>
                    <a:bodyPr/>
                    <a:lstStyle/>
                    <a:p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Brinkman Index (Median)</a:t>
                      </a:r>
                      <a:endParaRPr kumimoji="1" lang="ja-JP" altLang="en-US" sz="1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-2880 (750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-1600 (600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6831509"/>
                  </a:ext>
                </a:extLst>
              </a:tr>
              <a:tr h="229121">
                <a:tc rowSpan="4">
                  <a:txBody>
                    <a:bodyPr/>
                    <a:lstStyle/>
                    <a:p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ation</a:t>
                      </a:r>
                    </a:p>
                    <a:p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 tumo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opharynx (Total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 (48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(43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9714837"/>
                  </a:ext>
                </a:extLst>
              </a:tr>
              <a:tr h="229121">
                <a:tc vMerge="1">
                  <a:txBody>
                    <a:bodyPr/>
                    <a:lstStyle/>
                    <a:p>
                      <a:endParaRPr kumimoji="1" lang="en-US" altLang="ja-JP" sz="2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opharynx (p16+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 (66% of oropharynx)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 (75% of oropharynx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7783705"/>
                  </a:ext>
                </a:extLst>
              </a:tr>
              <a:tr h="229121">
                <a:tc vMerge="1">
                  <a:txBody>
                    <a:bodyPr/>
                    <a:lstStyle/>
                    <a:p>
                      <a:endParaRPr kumimoji="1" lang="en-US" altLang="ja-JP" sz="2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pharyn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 (41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 (30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0326385"/>
                  </a:ext>
                </a:extLst>
              </a:tr>
              <a:tr h="229121">
                <a:tc vMerge="1">
                  <a:txBody>
                    <a:bodyPr/>
                    <a:lstStyle/>
                    <a:p>
                      <a:endParaRPr kumimoji="1" lang="en-US" altLang="ja-JP" sz="2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ryn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(9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(14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929268"/>
                  </a:ext>
                </a:extLst>
              </a:tr>
              <a:tr h="229121">
                <a:tc rowSpan="4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ge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 (19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(18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3908665"/>
                  </a:ext>
                </a:extLst>
              </a:tr>
              <a:tr h="229121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2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(16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 (25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2274262"/>
                  </a:ext>
                </a:extLst>
              </a:tr>
              <a:tr h="229121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2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 (20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(18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9034756"/>
                  </a:ext>
                </a:extLst>
              </a:tr>
              <a:tr h="229121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2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 (45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 (39%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3629840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ED67B87-D1A5-E1BF-16D6-E6013058DB4B}"/>
              </a:ext>
            </a:extLst>
          </p:cNvPr>
          <p:cNvSpPr txBox="1"/>
          <p:nvPr/>
        </p:nvSpPr>
        <p:spPr>
          <a:xfrm>
            <a:off x="0" y="29089"/>
            <a:ext cx="709822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</a:t>
            </a:r>
            <a:r>
              <a:rPr kumimoji="1"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22839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F8B042F-9CEF-D691-9D80-357E73869F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BF06766C-B85F-27CC-B44B-1E89D59C4EE7}"/>
              </a:ext>
            </a:extLst>
          </p:cNvPr>
          <p:cNvGrpSpPr/>
          <p:nvPr/>
        </p:nvGrpSpPr>
        <p:grpSpPr>
          <a:xfrm>
            <a:off x="333590" y="2690132"/>
            <a:ext cx="11524819" cy="982708"/>
            <a:chOff x="599151" y="2603056"/>
            <a:chExt cx="8739640" cy="1478008"/>
          </a:xfrm>
        </p:grpSpPr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1C73C629-3786-4191-3455-DFCFAEA42582}"/>
                </a:ext>
              </a:extLst>
            </p:cNvPr>
            <p:cNvSpPr/>
            <p:nvPr/>
          </p:nvSpPr>
          <p:spPr>
            <a:xfrm>
              <a:off x="600996" y="3040103"/>
              <a:ext cx="1932039" cy="1040961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b="1" dirty="0">
                  <a:solidFill>
                    <a:schemeClr val="tx1"/>
                  </a:solidFill>
                  <a:latin typeface="Meiryo" panose="020B0604030504040204" pitchFamily="34" charset="-128"/>
                  <a:ea typeface="Meiryo" panose="020B0604030504040204" pitchFamily="34" charset="-128"/>
                </a:rPr>
                <a:t>DOC 50mg/m</a:t>
              </a:r>
              <a:r>
                <a:rPr kumimoji="1" lang="en-US" altLang="ja-JP" sz="1600" b="1" baseline="30000" dirty="0">
                  <a:solidFill>
                    <a:schemeClr val="tx1"/>
                  </a:solidFill>
                  <a:latin typeface="Meiryo" panose="020B0604030504040204" pitchFamily="34" charset="-128"/>
                  <a:ea typeface="Meiryo" panose="020B0604030504040204" pitchFamily="34" charset="-128"/>
                </a:rPr>
                <a:t>2</a:t>
              </a:r>
              <a:endParaRPr kumimoji="1" lang="ja-JP" altLang="en-US" sz="1600" b="1" baseline="3000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4B78E3BF-83D3-7C4F-939C-32BA6727B263}"/>
                </a:ext>
              </a:extLst>
            </p:cNvPr>
            <p:cNvSpPr/>
            <p:nvPr/>
          </p:nvSpPr>
          <p:spPr>
            <a:xfrm>
              <a:off x="2531191" y="3040103"/>
              <a:ext cx="4010949" cy="1040961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b="1" dirty="0">
                  <a:solidFill>
                    <a:schemeClr val="tx1"/>
                  </a:solidFill>
                  <a:latin typeface="Meiryo" panose="020B0604030504040204" pitchFamily="34" charset="-128"/>
                  <a:ea typeface="Meiryo" panose="020B0604030504040204" pitchFamily="34" charset="-128"/>
                </a:rPr>
                <a:t>CDDP</a:t>
              </a:r>
            </a:p>
            <a:p>
              <a:pPr algn="ctr"/>
              <a:r>
                <a:rPr kumimoji="1" lang="en-US" altLang="ja-JP" sz="1600" b="1" dirty="0">
                  <a:solidFill>
                    <a:schemeClr val="tx1"/>
                  </a:solidFill>
                  <a:latin typeface="Meiryo" panose="020B0604030504040204" pitchFamily="34" charset="-128"/>
                  <a:ea typeface="Meiryo" panose="020B0604030504040204" pitchFamily="34" charset="-128"/>
                </a:rPr>
                <a:t>15mg/m</a:t>
              </a:r>
              <a:r>
                <a:rPr kumimoji="1" lang="en-US" altLang="ja-JP" sz="1600" b="1" baseline="30000" dirty="0">
                  <a:solidFill>
                    <a:schemeClr val="tx1"/>
                  </a:solidFill>
                  <a:latin typeface="Meiryo" panose="020B0604030504040204" pitchFamily="34" charset="-128"/>
                  <a:ea typeface="Meiryo" panose="020B0604030504040204" pitchFamily="34" charset="-128"/>
                </a:rPr>
                <a:t>2 </a:t>
              </a:r>
              <a:r>
                <a:rPr kumimoji="1" lang="en-US" altLang="ja-JP" sz="1600" b="1" dirty="0">
                  <a:solidFill>
                    <a:schemeClr val="tx1"/>
                  </a:solidFill>
                  <a:latin typeface="Meiryo" panose="020B0604030504040204" pitchFamily="34" charset="-128"/>
                  <a:ea typeface="Meiryo" panose="020B0604030504040204" pitchFamily="34" charset="-128"/>
                </a:rPr>
                <a:t>x4 (60mg/course)</a:t>
              </a:r>
              <a:endParaRPr kumimoji="1" lang="ja-JP" altLang="en-US" sz="1600" b="1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ABDE4FC9-D5F4-E63C-73F9-00A476D37484}"/>
                </a:ext>
              </a:extLst>
            </p:cNvPr>
            <p:cNvSpPr/>
            <p:nvPr/>
          </p:nvSpPr>
          <p:spPr>
            <a:xfrm>
              <a:off x="6542141" y="3048368"/>
              <a:ext cx="2796650" cy="1032696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800" b="1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39D85175-4BC7-E803-D47E-25ABF10A452E}"/>
                </a:ext>
              </a:extLst>
            </p:cNvPr>
            <p:cNvSpPr txBox="1"/>
            <p:nvPr/>
          </p:nvSpPr>
          <p:spPr>
            <a:xfrm>
              <a:off x="599151" y="2603056"/>
              <a:ext cx="19320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rgbClr val="002060"/>
                  </a:solidFill>
                  <a:latin typeface="Meiryo" panose="020B0604030504040204" pitchFamily="34" charset="-128"/>
                  <a:ea typeface="Meiryo" panose="020B0604030504040204" pitchFamily="34" charset="-128"/>
                </a:rPr>
                <a:t>Day 1</a:t>
              </a:r>
              <a:endParaRPr kumimoji="1" lang="ja-JP" altLang="en-US" b="1">
                <a:solidFill>
                  <a:srgbClr val="002060"/>
                </a:solidFill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159BB0B9-F2E2-B654-AA47-EEE30BF3D01A}"/>
                </a:ext>
              </a:extLst>
            </p:cNvPr>
            <p:cNvSpPr txBox="1"/>
            <p:nvPr/>
          </p:nvSpPr>
          <p:spPr>
            <a:xfrm>
              <a:off x="2531191" y="2603056"/>
              <a:ext cx="4010949" cy="555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rgbClr val="002060"/>
                  </a:solidFill>
                  <a:latin typeface="Meiryo" panose="020B0604030504040204" pitchFamily="34" charset="-128"/>
                  <a:ea typeface="Meiryo" panose="020B0604030504040204" pitchFamily="34" charset="-128"/>
                </a:rPr>
                <a:t>Day 2-5</a:t>
              </a:r>
              <a:endParaRPr kumimoji="1" lang="ja-JP" altLang="en-US" b="1">
                <a:solidFill>
                  <a:srgbClr val="002060"/>
                </a:solidFill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C83F6619-A856-4614-FEA7-D195D26CCE6E}"/>
                </a:ext>
              </a:extLst>
            </p:cNvPr>
            <p:cNvSpPr txBox="1"/>
            <p:nvPr/>
          </p:nvSpPr>
          <p:spPr>
            <a:xfrm>
              <a:off x="6542140" y="2607860"/>
              <a:ext cx="2796651" cy="555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solidFill>
                    <a:srgbClr val="002060"/>
                  </a:solidFill>
                  <a:latin typeface="Meiryo" panose="020B0604030504040204" pitchFamily="34" charset="-128"/>
                  <a:ea typeface="Meiryo" panose="020B0604030504040204" pitchFamily="34" charset="-128"/>
                </a:rPr>
                <a:t>〜Day 21</a:t>
              </a:r>
              <a:endParaRPr kumimoji="1" lang="ja-JP" altLang="en-US" b="1">
                <a:solidFill>
                  <a:srgbClr val="002060"/>
                </a:solidFill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A82033C-6540-8A33-2BAD-29BA06781F14}"/>
              </a:ext>
            </a:extLst>
          </p:cNvPr>
          <p:cNvSpPr txBox="1"/>
          <p:nvPr/>
        </p:nvSpPr>
        <p:spPr>
          <a:xfrm>
            <a:off x="0" y="29089"/>
            <a:ext cx="61942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33614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23832E5-08B9-DCCF-0869-0E1BEB24A3B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EDD0B08-8AD5-2E38-80E2-0D559C43D545}"/>
              </a:ext>
            </a:extLst>
          </p:cNvPr>
          <p:cNvSpPr txBox="1"/>
          <p:nvPr/>
        </p:nvSpPr>
        <p:spPr>
          <a:xfrm>
            <a:off x="4206086" y="4441816"/>
            <a:ext cx="13885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Meiryo" panose="020B0604030504040204" pitchFamily="34" charset="-128"/>
                <a:ea typeface="Meiryo" panose="020B0604030504040204" pitchFamily="34" charset="-128"/>
              </a:rPr>
              <a:t>*p&lt;0.001</a:t>
            </a:r>
            <a:endParaRPr kumimoji="1" lang="ja-JP" altLang="en-US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C6450D2-29D6-4BB9-9410-9EE60D3DF791}"/>
              </a:ext>
            </a:extLst>
          </p:cNvPr>
          <p:cNvSpPr txBox="1"/>
          <p:nvPr/>
        </p:nvSpPr>
        <p:spPr>
          <a:xfrm>
            <a:off x="10214750" y="4575057"/>
            <a:ext cx="13885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Meiryo" panose="020B0604030504040204" pitchFamily="34" charset="-128"/>
                <a:ea typeface="Meiryo" panose="020B0604030504040204" pitchFamily="34" charset="-128"/>
              </a:rPr>
              <a:t>*p&lt;0.001</a:t>
            </a:r>
            <a:endParaRPr kumimoji="1" lang="ja-JP" altLang="en-US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8E5572F-68AE-A84E-8DAD-D7657BB40CBC}"/>
              </a:ext>
            </a:extLst>
          </p:cNvPr>
          <p:cNvSpPr txBox="1"/>
          <p:nvPr/>
        </p:nvSpPr>
        <p:spPr>
          <a:xfrm>
            <a:off x="0" y="29089"/>
            <a:ext cx="61942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FEE4A402-F333-AED3-026B-B10E31DEA1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266" y="1641269"/>
            <a:ext cx="5765734" cy="449961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7794ECA7-00B7-C30B-3548-74440C4C32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38087" y="1641268"/>
            <a:ext cx="5553913" cy="449961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39507CC-78BD-EA86-0D83-7BCD9BA7F57F}"/>
              </a:ext>
            </a:extLst>
          </p:cNvPr>
          <p:cNvSpPr txBox="1"/>
          <p:nvPr/>
        </p:nvSpPr>
        <p:spPr>
          <a:xfrm>
            <a:off x="0" y="990383"/>
            <a:ext cx="41444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2E354B3-F31D-9B27-A0A4-5FDA6D19564A}"/>
              </a:ext>
            </a:extLst>
          </p:cNvPr>
          <p:cNvSpPr txBox="1"/>
          <p:nvPr/>
        </p:nvSpPr>
        <p:spPr>
          <a:xfrm>
            <a:off x="6338329" y="990383"/>
            <a:ext cx="41444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18067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020BDF1-39AE-37DE-5C89-E6CD324A2D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49C75F4-39CB-02C6-5306-C30188544550}"/>
              </a:ext>
            </a:extLst>
          </p:cNvPr>
          <p:cNvSpPr txBox="1"/>
          <p:nvPr/>
        </p:nvSpPr>
        <p:spPr>
          <a:xfrm>
            <a:off x="0" y="29089"/>
            <a:ext cx="61942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0967C5F-BAEC-F218-D38F-7F5EDCBDF5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3541" y="1382670"/>
            <a:ext cx="9061454" cy="505931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B3EE375-04A1-93C7-8141-8A248A586CAC}"/>
              </a:ext>
            </a:extLst>
          </p:cNvPr>
          <p:cNvSpPr txBox="1"/>
          <p:nvPr/>
        </p:nvSpPr>
        <p:spPr>
          <a:xfrm>
            <a:off x="7056242" y="4633530"/>
            <a:ext cx="1644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Meiryo" panose="020B0604030504040204" pitchFamily="34" charset="-128"/>
                <a:ea typeface="Meiryo" panose="020B0604030504040204" pitchFamily="34" charset="-128"/>
              </a:rPr>
              <a:t>p=0.4</a:t>
            </a:r>
            <a:endParaRPr kumimoji="1" lang="ja-JP" altLang="en-US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164681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618BEE15-C1B6-02FB-211D-FE6B79573E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17195" y="736975"/>
            <a:ext cx="4622800" cy="29337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82B3A722-952A-3965-6749-038E56E838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8578" y="873863"/>
            <a:ext cx="4622800" cy="29337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D53D8CEF-EC92-C955-B2BC-FD23E6977C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17195" y="3966872"/>
            <a:ext cx="4622800" cy="29337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6845F169-38B3-75B5-F357-5C4BAC960B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78578" y="3996736"/>
            <a:ext cx="4622800" cy="29337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51C64BE-14D7-9E61-328E-354BAC93A8DC}"/>
              </a:ext>
            </a:extLst>
          </p:cNvPr>
          <p:cNvSpPr txBox="1"/>
          <p:nvPr/>
        </p:nvSpPr>
        <p:spPr>
          <a:xfrm>
            <a:off x="9948158" y="2645880"/>
            <a:ext cx="8653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=0.6</a:t>
            </a:r>
            <a:endParaRPr kumimoji="1" lang="ja-JP" altLang="en-US" sz="16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A7C090A-E200-BA14-2919-0BA689D1C116}"/>
              </a:ext>
            </a:extLst>
          </p:cNvPr>
          <p:cNvSpPr txBox="1"/>
          <p:nvPr/>
        </p:nvSpPr>
        <p:spPr>
          <a:xfrm>
            <a:off x="3714570" y="2529886"/>
            <a:ext cx="8653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=0.9</a:t>
            </a:r>
            <a:endParaRPr kumimoji="1" lang="ja-JP" altLang="en-US" sz="16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4420162-0BE0-4972-6922-0870126F6B48}"/>
              </a:ext>
            </a:extLst>
          </p:cNvPr>
          <p:cNvSpPr txBox="1"/>
          <p:nvPr/>
        </p:nvSpPr>
        <p:spPr>
          <a:xfrm>
            <a:off x="10077943" y="5931749"/>
            <a:ext cx="8653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=0.1</a:t>
            </a:r>
            <a:endParaRPr kumimoji="1" lang="ja-JP" altLang="en-US" sz="16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649024B-EEA7-39A6-249A-A45CF145B0B9}"/>
              </a:ext>
            </a:extLst>
          </p:cNvPr>
          <p:cNvSpPr txBox="1"/>
          <p:nvPr/>
        </p:nvSpPr>
        <p:spPr>
          <a:xfrm>
            <a:off x="3714570" y="5900022"/>
            <a:ext cx="8653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=0.9</a:t>
            </a:r>
            <a:endParaRPr kumimoji="1" lang="ja-JP" altLang="en-US" sz="16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684122D-03B4-74D8-9E61-939BAF52F504}"/>
              </a:ext>
            </a:extLst>
          </p:cNvPr>
          <p:cNvSpPr txBox="1"/>
          <p:nvPr/>
        </p:nvSpPr>
        <p:spPr>
          <a:xfrm>
            <a:off x="0" y="29089"/>
            <a:ext cx="61942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476A423-B52F-3812-4A40-A7735B8ABA75}"/>
              </a:ext>
            </a:extLst>
          </p:cNvPr>
          <p:cNvSpPr txBox="1"/>
          <p:nvPr/>
        </p:nvSpPr>
        <p:spPr>
          <a:xfrm>
            <a:off x="10706" y="595071"/>
            <a:ext cx="11257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65254D0-0789-CB5F-2D2C-8D537BE1D104}"/>
              </a:ext>
            </a:extLst>
          </p:cNvPr>
          <p:cNvSpPr txBox="1"/>
          <p:nvPr/>
        </p:nvSpPr>
        <p:spPr>
          <a:xfrm>
            <a:off x="10706" y="3461703"/>
            <a:ext cx="11257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620B719-260E-A64B-A229-57D79F51FC1C}"/>
              </a:ext>
            </a:extLst>
          </p:cNvPr>
          <p:cNvSpPr txBox="1"/>
          <p:nvPr/>
        </p:nvSpPr>
        <p:spPr>
          <a:xfrm>
            <a:off x="6129228" y="595071"/>
            <a:ext cx="11257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0A72154-E56D-3236-F8A3-C067259D03F4}"/>
              </a:ext>
            </a:extLst>
          </p:cNvPr>
          <p:cNvSpPr txBox="1"/>
          <p:nvPr/>
        </p:nvSpPr>
        <p:spPr>
          <a:xfrm>
            <a:off x="6127159" y="3449581"/>
            <a:ext cx="11257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31009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DB65C606-5243-52E9-47B8-CD7E1E5543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4715" y="3886203"/>
            <a:ext cx="4622800" cy="29337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8B666472-9166-5266-013E-6C897996D2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6006" y="3886203"/>
            <a:ext cx="4622800" cy="29337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900C714-A655-10D4-03E9-957BED0D78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74715" y="679043"/>
            <a:ext cx="4622800" cy="29337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BA0D161F-0DA7-1CEF-A3A9-06F85748989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26006" y="679043"/>
            <a:ext cx="4622800" cy="294640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A70E345-D277-15CD-81D0-5F90AE67F2F9}"/>
              </a:ext>
            </a:extLst>
          </p:cNvPr>
          <p:cNvSpPr txBox="1"/>
          <p:nvPr/>
        </p:nvSpPr>
        <p:spPr>
          <a:xfrm>
            <a:off x="9589485" y="2517945"/>
            <a:ext cx="8653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=0.4</a:t>
            </a:r>
            <a:endParaRPr kumimoji="1" lang="ja-JP" altLang="en-US" sz="16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02F15B2-8279-F0C1-2537-4DDAD40A53D1}"/>
              </a:ext>
            </a:extLst>
          </p:cNvPr>
          <p:cNvSpPr txBox="1"/>
          <p:nvPr/>
        </p:nvSpPr>
        <p:spPr>
          <a:xfrm>
            <a:off x="4057857" y="2517945"/>
            <a:ext cx="8653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=0.2</a:t>
            </a:r>
            <a:endParaRPr kumimoji="1" lang="ja-JP" altLang="en-US" sz="16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E2A712F-1F7B-E038-F5D6-F682EA5F6168}"/>
              </a:ext>
            </a:extLst>
          </p:cNvPr>
          <p:cNvSpPr txBox="1"/>
          <p:nvPr/>
        </p:nvSpPr>
        <p:spPr>
          <a:xfrm>
            <a:off x="9607382" y="5767506"/>
            <a:ext cx="13654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=0.48</a:t>
            </a:r>
            <a:endParaRPr kumimoji="1" lang="ja-JP" altLang="en-US" sz="16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F75A74A-518B-C767-01B7-1EA4306848B9}"/>
              </a:ext>
            </a:extLst>
          </p:cNvPr>
          <p:cNvSpPr txBox="1"/>
          <p:nvPr/>
        </p:nvSpPr>
        <p:spPr>
          <a:xfrm>
            <a:off x="4075754" y="5767506"/>
            <a:ext cx="1227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lang="en-US" altLang="ja-JP" sz="1600" b="1" dirty="0">
                <a:latin typeface="Meiryo" panose="020B0604030504040204" pitchFamily="34" charset="-128"/>
                <a:ea typeface="Meiryo" panose="020B0604030504040204" pitchFamily="34" charset="-128"/>
              </a:rPr>
              <a:t>=0.02</a:t>
            </a:r>
            <a:endParaRPr kumimoji="1" lang="ja-JP" altLang="en-US" sz="1600" b="1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9B42B9D-A13B-55A1-4A70-90D8A2974820}"/>
              </a:ext>
            </a:extLst>
          </p:cNvPr>
          <p:cNvSpPr txBox="1"/>
          <p:nvPr/>
        </p:nvSpPr>
        <p:spPr>
          <a:xfrm>
            <a:off x="10706" y="595071"/>
            <a:ext cx="11257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5480620-D0A7-6303-28B1-13A0551D1CC5}"/>
              </a:ext>
            </a:extLst>
          </p:cNvPr>
          <p:cNvSpPr txBox="1"/>
          <p:nvPr/>
        </p:nvSpPr>
        <p:spPr>
          <a:xfrm>
            <a:off x="10706" y="3461703"/>
            <a:ext cx="11257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6C58A02-BBC9-379B-354C-854D14E2B16A}"/>
              </a:ext>
            </a:extLst>
          </p:cNvPr>
          <p:cNvSpPr txBox="1"/>
          <p:nvPr/>
        </p:nvSpPr>
        <p:spPr>
          <a:xfrm>
            <a:off x="6129228" y="647324"/>
            <a:ext cx="11257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7604561-DC4F-1D5B-AA93-A13E04BD9D44}"/>
              </a:ext>
            </a:extLst>
          </p:cNvPr>
          <p:cNvSpPr txBox="1"/>
          <p:nvPr/>
        </p:nvSpPr>
        <p:spPr>
          <a:xfrm>
            <a:off x="6127159" y="3501834"/>
            <a:ext cx="11257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8994FF9-2ACB-558A-0FB3-559DAE2E4F5B}"/>
              </a:ext>
            </a:extLst>
          </p:cNvPr>
          <p:cNvSpPr txBox="1"/>
          <p:nvPr/>
        </p:nvSpPr>
        <p:spPr>
          <a:xfrm>
            <a:off x="0" y="29089"/>
            <a:ext cx="61942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4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7259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597</TotalTime>
  <Words>278</Words>
  <Application>Microsoft Macintosh PowerPoint</Application>
  <PresentationFormat>ワイド画面</PresentationFormat>
  <Paragraphs>91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2" baseType="lpstr">
      <vt:lpstr>Meiryo</vt:lpstr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kumi Kumai</dc:creator>
  <cp:lastModifiedBy>Takumi Kumai</cp:lastModifiedBy>
  <cp:revision>97</cp:revision>
  <cp:lastPrinted>2025-10-03T01:32:56Z</cp:lastPrinted>
  <dcterms:created xsi:type="dcterms:W3CDTF">2024-12-12T23:22:58Z</dcterms:created>
  <dcterms:modified xsi:type="dcterms:W3CDTF">2025-12-05T03:53:07Z</dcterms:modified>
</cp:coreProperties>
</file>